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3" r:id="rId3"/>
    <p:sldId id="265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53" autoAdjust="0"/>
    <p:restoredTop sz="96224" autoAdjust="0"/>
  </p:normalViewPr>
  <p:slideViewPr>
    <p:cSldViewPr>
      <p:cViewPr>
        <p:scale>
          <a:sx n="96" d="100"/>
          <a:sy n="96" d="100"/>
        </p:scale>
        <p:origin x="2448" y="3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4/10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3809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24579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4/10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1.tif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hyperlink" Target="http://creativecommons.org/licenses/by/4.0/" TargetMode="External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Elliott et al (2019) Diabetologia DOI 10.1007/s00125-019-05011-8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ummary of pathways that produce an intergenerational association between GDM and offspring type 2 diabetes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3ED9DB0-0534-4259-95A2-0D2C6337C16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9841" y="1259406"/>
            <a:ext cx="7164318" cy="45484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Elliott et al (2019) Diabetologia DOI 10.1007/s00125-019-05011-8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n overview of the PubMed search strategy to identify studies of interest</a:t>
            </a:r>
          </a:p>
        </p:txBody>
      </p:sp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01A6692E-6C64-41F5-B848-27017530856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1558" y="660758"/>
            <a:ext cx="6500884" cy="53117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8253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468848" y="6266559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8778" y="6034066"/>
            <a:ext cx="88840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Elliott et al (2019) Diabetologia DOI 10.1007/s00125-019-05011-8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8467" y="44624"/>
            <a:ext cx="91355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Human epigenetic studies related to GDM or hyperglycaemia in pregnancy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71C706A9-DF65-4650-A214-67999DA6AEFC}"/>
              </a:ext>
            </a:extLst>
          </p:cNvPr>
          <p:cNvGrpSpPr/>
          <p:nvPr/>
        </p:nvGrpSpPr>
        <p:grpSpPr>
          <a:xfrm>
            <a:off x="46007" y="444735"/>
            <a:ext cx="9005218" cy="5864585"/>
            <a:chOff x="46007" y="444735"/>
            <a:chExt cx="9005218" cy="5864585"/>
          </a:xfrm>
        </p:grpSpPr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C1C3596D-339C-4349-AC12-FB18C6DA4E62}"/>
                </a:ext>
              </a:extLst>
            </p:cNvPr>
            <p:cNvGrpSpPr/>
            <p:nvPr/>
          </p:nvGrpSpPr>
          <p:grpSpPr>
            <a:xfrm>
              <a:off x="46007" y="444735"/>
              <a:ext cx="9005218" cy="5864585"/>
              <a:chOff x="31279" y="444735"/>
              <a:chExt cx="9005218" cy="5864585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F18E8A00-F5F7-4970-9E75-C3FBF3BA7DF0}"/>
                  </a:ext>
                </a:extLst>
              </p:cNvPr>
              <p:cNvSpPr/>
              <p:nvPr/>
            </p:nvSpPr>
            <p:spPr>
              <a:xfrm>
                <a:off x="2144051" y="2159251"/>
                <a:ext cx="2952328" cy="2880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BC3FFE4F-86F8-4228-B096-339D2C582A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907704" y="530737"/>
                <a:ext cx="5904656" cy="1852205"/>
              </a:xfrm>
              <a:prstGeom prst="rect">
                <a:avLst/>
              </a:prstGeom>
            </p:spPr>
          </p:pic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B297D43F-2CB3-489D-B064-723CA046A155}"/>
                  </a:ext>
                </a:extLst>
              </p:cNvPr>
              <p:cNvSpPr/>
              <p:nvPr/>
            </p:nvSpPr>
            <p:spPr>
              <a:xfrm>
                <a:off x="2051720" y="2348880"/>
                <a:ext cx="2592288" cy="9840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9DA8A47E-A3F5-4C5F-A3A3-EDB1659572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141407" y="955291"/>
                <a:ext cx="838305" cy="219843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2B771886-3FEB-4AA7-819B-36A5D212D7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1144983" y="1164610"/>
                <a:ext cx="791389" cy="200021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AA14DB39-314B-41D2-84A4-8A9EB94D68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142248" y="1364111"/>
                <a:ext cx="771493" cy="207112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83DA7483-4E11-49C7-9524-C7333195378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1279" y="2467406"/>
                <a:ext cx="4565891" cy="1753682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AD152375-D4FA-4A4B-83E7-646DF3254D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586389" y="2504434"/>
                <a:ext cx="4450107" cy="1692469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FB96DA15-46F6-4A92-8CB9-9B42407519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69415" y="4491835"/>
                <a:ext cx="5990817" cy="1817485"/>
              </a:xfrm>
              <a:prstGeom prst="rect">
                <a:avLst/>
              </a:prstGeom>
            </p:spPr>
          </p:pic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5A9E0D80-EF76-4E80-832C-47AA2E7EC8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685147" y="4747577"/>
                <a:ext cx="1567401" cy="313683"/>
              </a:xfrm>
              <a:prstGeom prst="rect">
                <a:avLst/>
              </a:prstGeom>
            </p:spPr>
          </p:pic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C8AC1D3F-212B-4C5B-AB47-41F6EA520B1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6685147" y="5061260"/>
                <a:ext cx="1845210" cy="300102"/>
              </a:xfrm>
              <a:prstGeom prst="rect">
                <a:avLst/>
              </a:prstGeom>
            </p:spPr>
          </p:pic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D439838E-408E-47A2-A004-E4C6D51C972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6678322" y="5350168"/>
                <a:ext cx="1602711" cy="318269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7ADD71E3-EB45-49E7-8D52-C6192974E0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6679005" y="5672804"/>
                <a:ext cx="1704825" cy="493775"/>
              </a:xfrm>
              <a:prstGeom prst="rect">
                <a:avLst/>
              </a:prstGeom>
            </p:spPr>
          </p:pic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0852B284-FADD-44AC-B76C-B9B2C1AAAD6F}"/>
                  </a:ext>
                </a:extLst>
              </p:cNvPr>
              <p:cNvSpPr/>
              <p:nvPr/>
            </p:nvSpPr>
            <p:spPr>
              <a:xfrm>
                <a:off x="48778" y="444735"/>
                <a:ext cx="8987718" cy="1971638"/>
              </a:xfrm>
              <a:prstGeom prst="rect">
                <a:avLst/>
              </a:prstGeom>
              <a:noFill/>
              <a:ln>
                <a:solidFill>
                  <a:schemeClr val="accent5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A55C2C0D-0C68-4B0A-92D4-B85BFD504F6E}"/>
                  </a:ext>
                </a:extLst>
              </p:cNvPr>
              <p:cNvSpPr/>
              <p:nvPr/>
            </p:nvSpPr>
            <p:spPr>
              <a:xfrm>
                <a:off x="48778" y="2420739"/>
                <a:ext cx="4523222" cy="2019681"/>
              </a:xfrm>
              <a:prstGeom prst="rect">
                <a:avLst/>
              </a:prstGeom>
              <a:noFill/>
              <a:ln>
                <a:solidFill>
                  <a:schemeClr val="accent5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9EFCFF7E-0100-4719-B4B7-C727A0334BBF}"/>
                  </a:ext>
                </a:extLst>
              </p:cNvPr>
              <p:cNvSpPr/>
              <p:nvPr/>
            </p:nvSpPr>
            <p:spPr>
              <a:xfrm>
                <a:off x="4572001" y="2420941"/>
                <a:ext cx="4464496" cy="2019681"/>
              </a:xfrm>
              <a:prstGeom prst="rect">
                <a:avLst/>
              </a:prstGeom>
              <a:noFill/>
              <a:ln>
                <a:solidFill>
                  <a:schemeClr val="accent5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1CC6D7A9-864F-4CEA-A452-AA0E7985087F}"/>
                  </a:ext>
                </a:extLst>
              </p:cNvPr>
              <p:cNvSpPr/>
              <p:nvPr/>
            </p:nvSpPr>
            <p:spPr>
              <a:xfrm>
                <a:off x="48778" y="4434307"/>
                <a:ext cx="8987718" cy="1817485"/>
              </a:xfrm>
              <a:prstGeom prst="rect">
                <a:avLst/>
              </a:prstGeom>
              <a:noFill/>
              <a:ln>
                <a:solidFill>
                  <a:schemeClr val="accent5">
                    <a:lumMod val="20000"/>
                    <a:lumOff val="8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92617475-16A5-4C8F-A8DE-D4CAB98BC573}"/>
                </a:ext>
              </a:extLst>
            </p:cNvPr>
            <p:cNvSpPr/>
            <p:nvPr/>
          </p:nvSpPr>
          <p:spPr>
            <a:xfrm>
              <a:off x="8100392" y="2492896"/>
              <a:ext cx="195369" cy="1539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858679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</TotalTime>
  <Words>160</Words>
  <Application>Microsoft Office PowerPoint</Application>
  <PresentationFormat>On-screen Show (4:3)</PresentationFormat>
  <Paragraphs>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3</cp:revision>
  <dcterms:created xsi:type="dcterms:W3CDTF">2016-06-15T12:53:43Z</dcterms:created>
  <dcterms:modified xsi:type="dcterms:W3CDTF">2019-10-04T14:05:51Z</dcterms:modified>
</cp:coreProperties>
</file>